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94" r:id="rId2"/>
    <p:sldId id="280" r:id="rId3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55" autoAdjust="0"/>
    <p:restoredTop sz="94660"/>
  </p:normalViewPr>
  <p:slideViewPr>
    <p:cSldViewPr snapToGrid="0">
      <p:cViewPr varScale="1">
        <p:scale>
          <a:sx n="64" d="100"/>
          <a:sy n="64" d="100"/>
        </p:scale>
        <p:origin x="29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7DE9CA-35BF-437E-B3CE-3AEA0FCDD60D}" type="datetimeFigureOut">
              <a:rPr kumimoji="1" lang="ja-JP" altLang="en-US" smtClean="0"/>
              <a:t>2020/10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A63EA-AFBB-4029-A760-1C0115CE11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2917FBEB-C8AC-47E9-A6FC-F6EF6A6785DA}"/>
              </a:ext>
            </a:extLst>
          </p:cNvPr>
          <p:cNvSpPr txBox="1"/>
          <p:nvPr/>
        </p:nvSpPr>
        <p:spPr>
          <a:xfrm>
            <a:off x="663986" y="2986856"/>
            <a:ext cx="5784439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arbonization and H</a:t>
            </a:r>
            <a:r>
              <a:rPr lang="en-US" altLang="ja-JP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O</a:t>
            </a:r>
            <a:r>
              <a:rPr lang="en-US" altLang="ja-JP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activation of fern </a:t>
            </a:r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icranopteris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inearis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and electrochemical properties for electric double layer capacitor electrode</a:t>
            </a: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rang K. Trinh,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oshiki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Tsubota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Shuto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Takahashi, Nga T. Mai, Minh N. Nguyen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, and Nam H. Nguyen</a:t>
            </a:r>
            <a:endParaRPr lang="ja-JP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6150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</p:nvPr>
        </p:nvGraphicFramePr>
        <p:xfrm>
          <a:off x="470853" y="7104239"/>
          <a:ext cx="5915025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3477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0802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810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7787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19761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11569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SimSun" panose="02010600030101010101" pitchFamily="2" charset="-122"/>
                          <a:ea typeface="SimSun" panose="02010600030101010101" pitchFamily="2" charset="-122"/>
                          <a:cs typeface="SimSun" panose="02010600030101010101" pitchFamily="2" charset="-122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/ wt.%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 / wt.%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/ wt.%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 / wt.%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s / wt.%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600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61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4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4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1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:1 600C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72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4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5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6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:3 600C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77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3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6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5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0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100" name="Text Box 99"/>
          <p:cNvSpPr txBox="1"/>
          <p:nvPr/>
        </p:nvSpPr>
        <p:spPr>
          <a:xfrm>
            <a:off x="471805" y="6656705"/>
            <a:ext cx="5080000" cy="2755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/>
            <a:r>
              <a:rPr lang="en-US" sz="1200" b="0">
                <a:latin typeface="Times New Roman" panose="02020603050405020304" pitchFamily="18" charset="0"/>
                <a:ea typeface="SimSun" panose="02010600030101010101" pitchFamily="2" charset="-122"/>
              </a:rPr>
              <a:t>Table S2: CHN measurement for the samples activated with H</a:t>
            </a:r>
            <a:r>
              <a:rPr lang="en-US" sz="1200" b="0" baseline="-25000"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US" sz="1200" b="0">
                <a:latin typeface="Times New Roman" panose="02020603050405020304" pitchFamily="18" charset="0"/>
                <a:ea typeface="SimSun" panose="02010600030101010101" pitchFamily="2" charset="-122"/>
              </a:rPr>
              <a:t>PO</a:t>
            </a:r>
            <a:r>
              <a:rPr lang="en-US" sz="1200" b="0" baseline="-25000">
                <a:latin typeface="Times New Roman" panose="02020603050405020304" pitchFamily="18" charset="0"/>
                <a:ea typeface="SimSun" panose="02010600030101010101" pitchFamily="2" charset="-122"/>
              </a:rPr>
              <a:t>4</a:t>
            </a:r>
            <a:r>
              <a:rPr lang="en-US" sz="1200" b="0">
                <a:latin typeface="Times New Roman" panose="02020603050405020304" pitchFamily="18" charset="0"/>
                <a:ea typeface="SimSun" panose="02010600030101010101" pitchFamily="2" charset="-122"/>
              </a:rPr>
              <a:t>.</a:t>
            </a:r>
            <a:endParaRPr lang="en-US"/>
          </a:p>
        </p:txBody>
      </p:sp>
      <p:sp>
        <p:nvSpPr>
          <p:cNvPr id="6" name="Text Box 5"/>
          <p:cNvSpPr txBox="1"/>
          <p:nvPr/>
        </p:nvSpPr>
        <p:spPr>
          <a:xfrm>
            <a:off x="471805" y="2740660"/>
            <a:ext cx="5080000" cy="64516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/>
            <a:r>
              <a:rPr lang="en-US" sz="1200" b="0">
                <a:latin typeface="Times New Roman" panose="02020603050405020304" pitchFamily="18" charset="0"/>
                <a:ea typeface="SimSun" panose="02010600030101010101" pitchFamily="2" charset="-122"/>
              </a:rPr>
              <a:t>Table S1: Comparison among several biomass activated carbon prepared by H</a:t>
            </a:r>
            <a:r>
              <a:rPr lang="en-US" sz="1200" b="0" baseline="-25000">
                <a:latin typeface="Times New Roman" panose="02020603050405020304" pitchFamily="18" charset="0"/>
                <a:ea typeface="SimSun" panose="02010600030101010101" pitchFamily="2" charset="-122"/>
              </a:rPr>
              <a:t>3</a:t>
            </a:r>
            <a:r>
              <a:rPr lang="en-US" sz="1200" b="0">
                <a:latin typeface="Times New Roman" panose="02020603050405020304" pitchFamily="18" charset="0"/>
                <a:ea typeface="SimSun" panose="02010600030101010101" pitchFamily="2" charset="-122"/>
              </a:rPr>
              <a:t>PO</a:t>
            </a:r>
            <a:r>
              <a:rPr lang="en-US" sz="1200" b="0" baseline="-25000">
                <a:latin typeface="Times New Roman" panose="02020603050405020304" pitchFamily="18" charset="0"/>
                <a:ea typeface="SimSun" panose="02010600030101010101" pitchFamily="2" charset="-122"/>
              </a:rPr>
              <a:t>4</a:t>
            </a:r>
            <a:r>
              <a:rPr lang="en-US" sz="1200" b="0">
                <a:latin typeface="Times New Roman" panose="02020603050405020304" pitchFamily="18" charset="0"/>
                <a:ea typeface="SimSun" panose="02010600030101010101" pitchFamily="2" charset="-122"/>
              </a:rPr>
              <a:t> activation.</a:t>
            </a:r>
            <a:endParaRPr lang="en-US" sz="1200" b="1"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indent="0"/>
            <a:r>
              <a:rPr lang="en-US" sz="1200" b="1"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endParaRPr lang="en-US"/>
          </a:p>
        </p:txBody>
      </p:sp>
      <p:graphicFrame>
        <p:nvGraphicFramePr>
          <p:cNvPr id="7" name="Table 6"/>
          <p:cNvGraphicFramePr/>
          <p:nvPr/>
        </p:nvGraphicFramePr>
        <p:xfrm>
          <a:off x="471805" y="3385820"/>
          <a:ext cx="5340350" cy="25603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048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7946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9853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398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77787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 m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n-US" sz="1200" b="0" i="1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 cm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n-US" sz="1200" b="0" i="1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cro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 cm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n-US" sz="1200" b="0" i="1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 i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200" b="0" baseline="-25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so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/ cm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</a:t>
                      </a:r>
                      <a:r>
                        <a:rPr lang="en-US" sz="1200" b="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n-US" sz="1200" b="0" i="1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tton stalk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8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7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2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0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irm shell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0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1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ffee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0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2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2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ackfruit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0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2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3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tus stalks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8.78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2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4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te pits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5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5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8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7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5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ce husk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6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6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ja-JP"/>
                    </a:p>
                  </a:txBody>
                  <a:tcPr>
                    <a:lnB cap="flat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9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34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boo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2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6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3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4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live stone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8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5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rian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4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4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23]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cap="flat"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indent="0">
                        <a:buNone/>
                      </a:pP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2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2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</a:t>
                      </a:r>
                      <a:endParaRPr lang="en-US" sz="1200" b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r>
                        <a:rPr lang="en-US" sz="12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ur work</a:t>
                      </a:r>
                      <a:endParaRPr lang="en-US" sz="12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cap="flat">
                      <a:noFill/>
                    </a:lnR>
                    <a:lnT cap="flat">
                      <a:noFill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3</Words>
  <Application>Microsoft Office PowerPoint</Application>
  <PresentationFormat>A4 210 x 297 mm</PresentationFormat>
  <Paragraphs>10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ＭＳ Ｐゴシック</vt:lpstr>
      <vt:lpstr>SimSun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t</dc:creator>
  <cp:lastModifiedBy>tsubota</cp:lastModifiedBy>
  <cp:revision>123</cp:revision>
  <cp:lastPrinted>2019-11-22T04:51:00Z</cp:lastPrinted>
  <dcterms:created xsi:type="dcterms:W3CDTF">2019-11-19T04:17:00Z</dcterms:created>
  <dcterms:modified xsi:type="dcterms:W3CDTF">2020-10-29T15:20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9453</vt:lpwstr>
  </property>
</Properties>
</file>